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732" r:id="rId1"/>
  </p:sldMasterIdLst>
  <p:notesMasterIdLst>
    <p:notesMasterId r:id="rId3"/>
  </p:notesMasterIdLst>
  <p:sldIdLst>
    <p:sldId id="272" r:id="rId2"/>
  </p:sldIdLst>
  <p:sldSz cx="9144000" cy="5715000" type="screen16x10"/>
  <p:notesSz cx="9144000" cy="6858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5345E965-0140-ADE0-DB2C-DDC75760A289}" name="Alessandro Fatatis" initials="AF" userId="S::af39@drexel.edu::5421c82d-accb-43d6-bc52-f8c7455fa968" providerId="AD"/>
  <p188:author id="{0D443DB4-5F58-0368-B600-A387FC99D53C}" name="Dinatale,Anthony" initials="D" userId="S::acd84@drexel.edu::4c6ef405-d2be-481c-925d-4add091459fe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FFFC"/>
    <a:srgbClr val="2125FF"/>
    <a:srgbClr val="00B3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1011"/>
    <p:restoredTop sz="96327"/>
  </p:normalViewPr>
  <p:slideViewPr>
    <p:cSldViewPr snapToGrid="0" snapToObjects="1">
      <p:cViewPr varScale="1">
        <p:scale>
          <a:sx n="148" d="100"/>
          <a:sy n="148" d="100"/>
        </p:scale>
        <p:origin x="704" y="192"/>
      </p:cViewPr>
      <p:guideLst/>
    </p:cSldViewPr>
  </p:slideViewPr>
  <p:notesTextViewPr>
    <p:cViewPr>
      <p:scale>
        <a:sx n="114" d="100"/>
        <a:sy n="114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8/10/relationships/authors" Target="authors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2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79484" y="2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49FFED5-8238-1442-BCC4-7B81FEB7EF0C}" type="datetimeFigureOut">
              <a:rPr lang="en-US" smtClean="0"/>
              <a:t>11/2/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720975" y="857250"/>
            <a:ext cx="3702050" cy="2314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300412"/>
            <a:ext cx="7315200" cy="2700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79484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B518B98-75F2-1243-9ECC-791F8B5F4F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588547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816254" rtl="0" eaLnBrk="1" latinLnBrk="0" hangingPunct="1">
      <a:defRPr sz="1072" kern="1200">
        <a:solidFill>
          <a:schemeClr val="tx1"/>
        </a:solidFill>
        <a:latin typeface="+mn-lt"/>
        <a:ea typeface="+mn-ea"/>
        <a:cs typeface="+mn-cs"/>
      </a:defRPr>
    </a:lvl1pPr>
    <a:lvl2pPr marL="408127" algn="l" defTabSz="816254" rtl="0" eaLnBrk="1" latinLnBrk="0" hangingPunct="1">
      <a:defRPr sz="1072" kern="1200">
        <a:solidFill>
          <a:schemeClr val="tx1"/>
        </a:solidFill>
        <a:latin typeface="+mn-lt"/>
        <a:ea typeface="+mn-ea"/>
        <a:cs typeface="+mn-cs"/>
      </a:defRPr>
    </a:lvl2pPr>
    <a:lvl3pPr marL="816254" algn="l" defTabSz="816254" rtl="0" eaLnBrk="1" latinLnBrk="0" hangingPunct="1">
      <a:defRPr sz="1072" kern="1200">
        <a:solidFill>
          <a:schemeClr val="tx1"/>
        </a:solidFill>
        <a:latin typeface="+mn-lt"/>
        <a:ea typeface="+mn-ea"/>
        <a:cs typeface="+mn-cs"/>
      </a:defRPr>
    </a:lvl3pPr>
    <a:lvl4pPr marL="1224380" algn="l" defTabSz="816254" rtl="0" eaLnBrk="1" latinLnBrk="0" hangingPunct="1">
      <a:defRPr sz="1072" kern="1200">
        <a:solidFill>
          <a:schemeClr val="tx1"/>
        </a:solidFill>
        <a:latin typeface="+mn-lt"/>
        <a:ea typeface="+mn-ea"/>
        <a:cs typeface="+mn-cs"/>
      </a:defRPr>
    </a:lvl4pPr>
    <a:lvl5pPr marL="1632507" algn="l" defTabSz="816254" rtl="0" eaLnBrk="1" latinLnBrk="0" hangingPunct="1">
      <a:defRPr sz="1072" kern="1200">
        <a:solidFill>
          <a:schemeClr val="tx1"/>
        </a:solidFill>
        <a:latin typeface="+mn-lt"/>
        <a:ea typeface="+mn-ea"/>
        <a:cs typeface="+mn-cs"/>
      </a:defRPr>
    </a:lvl5pPr>
    <a:lvl6pPr marL="2040634" algn="l" defTabSz="816254" rtl="0" eaLnBrk="1" latinLnBrk="0" hangingPunct="1">
      <a:defRPr sz="1072" kern="1200">
        <a:solidFill>
          <a:schemeClr val="tx1"/>
        </a:solidFill>
        <a:latin typeface="+mn-lt"/>
        <a:ea typeface="+mn-ea"/>
        <a:cs typeface="+mn-cs"/>
      </a:defRPr>
    </a:lvl6pPr>
    <a:lvl7pPr marL="2448761" algn="l" defTabSz="816254" rtl="0" eaLnBrk="1" latinLnBrk="0" hangingPunct="1">
      <a:defRPr sz="1072" kern="1200">
        <a:solidFill>
          <a:schemeClr val="tx1"/>
        </a:solidFill>
        <a:latin typeface="+mn-lt"/>
        <a:ea typeface="+mn-ea"/>
        <a:cs typeface="+mn-cs"/>
      </a:defRPr>
    </a:lvl7pPr>
    <a:lvl8pPr marL="2856889" algn="l" defTabSz="816254" rtl="0" eaLnBrk="1" latinLnBrk="0" hangingPunct="1">
      <a:defRPr sz="1072" kern="1200">
        <a:solidFill>
          <a:schemeClr val="tx1"/>
        </a:solidFill>
        <a:latin typeface="+mn-lt"/>
        <a:ea typeface="+mn-ea"/>
        <a:cs typeface="+mn-cs"/>
      </a:defRPr>
    </a:lvl8pPr>
    <a:lvl9pPr marL="3265014" algn="l" defTabSz="816254" rtl="0" eaLnBrk="1" latinLnBrk="0" hangingPunct="1">
      <a:defRPr sz="1072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720975" y="857250"/>
            <a:ext cx="3702050" cy="2314575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D591124-4521-724D-8BFA-E3EDB7838D81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650128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143000" y="935302"/>
            <a:ext cx="6858000" cy="19896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001698"/>
            <a:ext cx="6858000" cy="1379802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F4ECDA-2057-5940-BDCA-6A029BEB357F}" type="datetimeFigureOut">
              <a:rPr lang="en-US" smtClean="0"/>
              <a:t>11/2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33A53D-963C-CC47-BB6D-21039588EB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67271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F4ECDA-2057-5940-BDCA-6A029BEB357F}" type="datetimeFigureOut">
              <a:rPr lang="en-US" smtClean="0"/>
              <a:t>11/2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33A53D-963C-CC47-BB6D-21039588EB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51681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04271"/>
            <a:ext cx="1971675" cy="484319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04271"/>
            <a:ext cx="5800725" cy="484319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F4ECDA-2057-5940-BDCA-6A029BEB357F}" type="datetimeFigureOut">
              <a:rPr lang="en-US" smtClean="0"/>
              <a:t>11/2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33A53D-963C-CC47-BB6D-21039588EB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01498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F4ECDA-2057-5940-BDCA-6A029BEB357F}" type="datetimeFigureOut">
              <a:rPr lang="en-US" smtClean="0"/>
              <a:t>11/2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33A53D-963C-CC47-BB6D-21039588EB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64723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424782"/>
            <a:ext cx="7886700" cy="2377281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3824553"/>
            <a:ext cx="7886700" cy="1250156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F4ECDA-2057-5940-BDCA-6A029BEB357F}" type="datetimeFigureOut">
              <a:rPr lang="en-US" smtClean="0"/>
              <a:t>11/2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33A53D-963C-CC47-BB6D-21039588EB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48694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521354"/>
            <a:ext cx="3886200" cy="362611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521354"/>
            <a:ext cx="3886200" cy="362611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F4ECDA-2057-5940-BDCA-6A029BEB357F}" type="datetimeFigureOut">
              <a:rPr lang="en-US" smtClean="0"/>
              <a:t>11/2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33A53D-963C-CC47-BB6D-21039588EB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79051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04271"/>
            <a:ext cx="7886700" cy="110463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400969"/>
            <a:ext cx="3868340" cy="686593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087563"/>
            <a:ext cx="3868340" cy="307049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400969"/>
            <a:ext cx="3887391" cy="686593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087563"/>
            <a:ext cx="3887391" cy="307049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F4ECDA-2057-5940-BDCA-6A029BEB357F}" type="datetimeFigureOut">
              <a:rPr lang="en-US" smtClean="0"/>
              <a:t>11/2/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33A53D-963C-CC47-BB6D-21039588EB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30790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F4ECDA-2057-5940-BDCA-6A029BEB357F}" type="datetimeFigureOut">
              <a:rPr lang="en-US" smtClean="0"/>
              <a:t>11/2/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33A53D-963C-CC47-BB6D-21039588EB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96565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F4ECDA-2057-5940-BDCA-6A029BEB357F}" type="datetimeFigureOut">
              <a:rPr lang="en-US" smtClean="0"/>
              <a:t>11/2/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33A53D-963C-CC47-BB6D-21039588EB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047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81000"/>
            <a:ext cx="2949178" cy="13335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822855"/>
            <a:ext cx="4629150" cy="4061354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1714500"/>
            <a:ext cx="2949178" cy="3176323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F4ECDA-2057-5940-BDCA-6A029BEB357F}" type="datetimeFigureOut">
              <a:rPr lang="en-US" smtClean="0"/>
              <a:t>11/2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33A53D-963C-CC47-BB6D-21039588EB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94880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81000"/>
            <a:ext cx="2949178" cy="13335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822855"/>
            <a:ext cx="4629150" cy="4061354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1714500"/>
            <a:ext cx="2949178" cy="3176323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F4ECDA-2057-5940-BDCA-6A029BEB357F}" type="datetimeFigureOut">
              <a:rPr lang="en-US" smtClean="0"/>
              <a:t>11/2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33A53D-963C-CC47-BB6D-21039588EB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53022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04271"/>
            <a:ext cx="7886700" cy="110463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521354"/>
            <a:ext cx="7886700" cy="362611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5296959"/>
            <a:ext cx="2057400" cy="30427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4ECDA-2057-5940-BDCA-6A029BEB357F}" type="datetimeFigureOut">
              <a:rPr lang="en-US" smtClean="0"/>
              <a:t>11/2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5296959"/>
            <a:ext cx="3086100" cy="30427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5296959"/>
            <a:ext cx="2057400" cy="30427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33A53D-963C-CC47-BB6D-21039588EB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44766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33" r:id="rId1"/>
    <p:sldLayoutId id="2147483734" r:id="rId2"/>
    <p:sldLayoutId id="2147483735" r:id="rId3"/>
    <p:sldLayoutId id="2147483736" r:id="rId4"/>
    <p:sldLayoutId id="2147483737" r:id="rId5"/>
    <p:sldLayoutId id="2147483738" r:id="rId6"/>
    <p:sldLayoutId id="2147483739" r:id="rId7"/>
    <p:sldLayoutId id="2147483740" r:id="rId8"/>
    <p:sldLayoutId id="2147483741" r:id="rId9"/>
    <p:sldLayoutId id="2147483742" r:id="rId10"/>
    <p:sldLayoutId id="214748374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emf"/><Relationship Id="rId5" Type="http://schemas.openxmlformats.org/officeDocument/2006/relationships/image" Target="../media/image3.emf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8" name="Picture 27">
            <a:extLst>
              <a:ext uri="{FF2B5EF4-FFF2-40B4-BE49-F238E27FC236}">
                <a16:creationId xmlns:a16="http://schemas.microsoft.com/office/drawing/2014/main" id="{A4810059-A2FD-1B45-92FE-3B77487DE09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051838" y="329572"/>
            <a:ext cx="2166100" cy="1860021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FB7623F9-DB2D-8340-B5A3-B071C2B683E3}"/>
              </a:ext>
            </a:extLst>
          </p:cNvPr>
          <p:cNvSpPr txBox="1"/>
          <p:nvPr/>
        </p:nvSpPr>
        <p:spPr>
          <a:xfrm>
            <a:off x="294069" y="4955895"/>
            <a:ext cx="8488221" cy="7386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: C4-2B cells exposed to Enzalutamide show a dose-dependent(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) and time- dependent increase in IL-1</a:t>
            </a:r>
            <a:r>
              <a:rPr lang="en-US" sz="1000" dirty="0"/>
              <a:t>β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expression (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). </a:t>
            </a:r>
          </a:p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Removal of enzalutamide after a 15-day treatment resulted in a return of IL-1</a:t>
            </a:r>
            <a:r>
              <a:rPr lang="en-US" sz="1100" dirty="0"/>
              <a:t>β</a:t>
            </a:r>
            <a:r>
              <a:rPr lang="en-US" sz="1000" dirty="0"/>
              <a:t>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expression to control (undetectable) levels (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). Same results were </a:t>
            </a:r>
          </a:p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obtained with 15-day hormone-deprivation followed by DHT re-addition (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). </a:t>
            </a:r>
          </a:p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. ***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= 0.0005;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. **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=0.0015 - ****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&lt;0.0001;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. ***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&lt;0.0001;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. ****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&lt;0.0001)  - One-way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Anova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E6FCF47F-9CFB-D74F-A531-E96060845321}"/>
              </a:ext>
            </a:extLst>
          </p:cNvPr>
          <p:cNvSpPr txBox="1"/>
          <p:nvPr/>
        </p:nvSpPr>
        <p:spPr>
          <a:xfrm>
            <a:off x="1698752" y="-85693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2A69DDCF-5AB1-8149-9A13-FFE04E4A5308}"/>
              </a:ext>
            </a:extLst>
          </p:cNvPr>
          <p:cNvSpPr txBox="1"/>
          <p:nvPr/>
        </p:nvSpPr>
        <p:spPr>
          <a:xfrm>
            <a:off x="4833581" y="-85693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76BEDAF2-1487-614E-BBDD-6AFF0A479E8A}"/>
              </a:ext>
            </a:extLst>
          </p:cNvPr>
          <p:cNvSpPr txBox="1"/>
          <p:nvPr/>
        </p:nvSpPr>
        <p:spPr>
          <a:xfrm>
            <a:off x="2011658" y="2109009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D749C2D3-61E3-2D42-B3EF-80C000FD2D24}"/>
              </a:ext>
            </a:extLst>
          </p:cNvPr>
          <p:cNvSpPr txBox="1"/>
          <p:nvPr/>
        </p:nvSpPr>
        <p:spPr>
          <a:xfrm>
            <a:off x="4667600" y="2109009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AAFB51A2-04B9-3940-8081-4AFCDDC50ACD}"/>
              </a:ext>
            </a:extLst>
          </p:cNvPr>
          <p:cNvSpPr txBox="1"/>
          <p:nvPr/>
        </p:nvSpPr>
        <p:spPr>
          <a:xfrm>
            <a:off x="6044156" y="268250"/>
            <a:ext cx="763351" cy="200055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Enzalutamide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462C794D-9099-1845-BEF6-0C52BC77B7EA}"/>
              </a:ext>
            </a:extLst>
          </p:cNvPr>
          <p:cNvSpPr txBox="1"/>
          <p:nvPr/>
        </p:nvSpPr>
        <p:spPr>
          <a:xfrm>
            <a:off x="3611096" y="433607"/>
            <a:ext cx="33374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34BD5555-DD08-8E43-ACCE-9685BCE54B21}"/>
              </a:ext>
            </a:extLst>
          </p:cNvPr>
          <p:cNvSpPr txBox="1"/>
          <p:nvPr/>
        </p:nvSpPr>
        <p:spPr>
          <a:xfrm>
            <a:off x="3966106" y="654163"/>
            <a:ext cx="33374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5F3179A3-FC6B-FC48-90BF-94219E2287E4}"/>
              </a:ext>
            </a:extLst>
          </p:cNvPr>
          <p:cNvSpPr txBox="1"/>
          <p:nvPr/>
        </p:nvSpPr>
        <p:spPr>
          <a:xfrm>
            <a:off x="6456311" y="1119408"/>
            <a:ext cx="2840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E062ED32-3616-4849-AC59-E0C1E03F0118}"/>
              </a:ext>
            </a:extLst>
          </p:cNvPr>
          <p:cNvSpPr txBox="1"/>
          <p:nvPr/>
        </p:nvSpPr>
        <p:spPr>
          <a:xfrm>
            <a:off x="6660314" y="526371"/>
            <a:ext cx="3834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****</a:t>
            </a:r>
          </a:p>
        </p:txBody>
      </p:sp>
      <p:pic>
        <p:nvPicPr>
          <p:cNvPr id="30" name="Picture 29">
            <a:extLst>
              <a:ext uri="{FF2B5EF4-FFF2-40B4-BE49-F238E27FC236}">
                <a16:creationId xmlns:a16="http://schemas.microsoft.com/office/drawing/2014/main" id="{4F224CB2-2CD2-5C48-82C0-9EB2D74BDED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011658" y="2754482"/>
            <a:ext cx="2011776" cy="1615757"/>
          </a:xfrm>
          <a:prstGeom prst="rect">
            <a:avLst/>
          </a:prstGeom>
        </p:spPr>
      </p:pic>
      <p:sp>
        <p:nvSpPr>
          <p:cNvPr id="31" name="TextBox 30">
            <a:extLst>
              <a:ext uri="{FF2B5EF4-FFF2-40B4-BE49-F238E27FC236}">
                <a16:creationId xmlns:a16="http://schemas.microsoft.com/office/drawing/2014/main" id="{AD57269D-A454-EF44-98EF-CBFCE1742F01}"/>
              </a:ext>
            </a:extLst>
          </p:cNvPr>
          <p:cNvSpPr txBox="1"/>
          <p:nvPr/>
        </p:nvSpPr>
        <p:spPr>
          <a:xfrm>
            <a:off x="3119002" y="2828251"/>
            <a:ext cx="3834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****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F411E0B1-BA9B-CB45-9C82-626F04FEC9D5}"/>
              </a:ext>
            </a:extLst>
          </p:cNvPr>
          <p:cNvSpPr txBox="1"/>
          <p:nvPr/>
        </p:nvSpPr>
        <p:spPr>
          <a:xfrm>
            <a:off x="2909070" y="2522487"/>
            <a:ext cx="763351" cy="200055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Enzalutamide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6FA1AB68-9F49-A042-BE4D-AE09BB39529B}"/>
              </a:ext>
            </a:extLst>
          </p:cNvPr>
          <p:cNvSpPr txBox="1"/>
          <p:nvPr/>
        </p:nvSpPr>
        <p:spPr>
          <a:xfrm>
            <a:off x="2634796" y="4310035"/>
            <a:ext cx="54854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9E696263-7167-E04A-B891-2E940FE0AB9C}"/>
              </a:ext>
            </a:extLst>
          </p:cNvPr>
          <p:cNvSpPr txBox="1"/>
          <p:nvPr/>
        </p:nvSpPr>
        <p:spPr>
          <a:xfrm>
            <a:off x="3039166" y="4413333"/>
            <a:ext cx="56457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15 days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BDAE25D1-A197-8A4A-BE9E-B75FBCE2641D}"/>
              </a:ext>
            </a:extLst>
          </p:cNvPr>
          <p:cNvSpPr txBox="1"/>
          <p:nvPr/>
        </p:nvSpPr>
        <p:spPr>
          <a:xfrm>
            <a:off x="3325416" y="4628777"/>
            <a:ext cx="93166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4 days removal</a:t>
            </a:r>
          </a:p>
        </p:txBody>
      </p:sp>
      <p:pic>
        <p:nvPicPr>
          <p:cNvPr id="43" name="Picture 42">
            <a:extLst>
              <a:ext uri="{FF2B5EF4-FFF2-40B4-BE49-F238E27FC236}">
                <a16:creationId xmlns:a16="http://schemas.microsoft.com/office/drawing/2014/main" id="{9AF9E313-370D-884A-8AEB-13EE99C7AE9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953260" y="293640"/>
            <a:ext cx="2582516" cy="1941220"/>
          </a:xfrm>
          <a:prstGeom prst="rect">
            <a:avLst/>
          </a:prstGeom>
        </p:spPr>
      </p:pic>
      <p:pic>
        <p:nvPicPr>
          <p:cNvPr id="26" name="Picture 25">
            <a:extLst>
              <a:ext uri="{FF2B5EF4-FFF2-40B4-BE49-F238E27FC236}">
                <a16:creationId xmlns:a16="http://schemas.microsoft.com/office/drawing/2014/main" id="{8890675C-9B33-9648-BDC0-D0E2B2CC6DE0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120568" y="2686449"/>
            <a:ext cx="2010641" cy="1614846"/>
          </a:xfrm>
          <a:prstGeom prst="rect">
            <a:avLst/>
          </a:prstGeom>
        </p:spPr>
      </p:pic>
      <p:sp>
        <p:nvSpPr>
          <p:cNvPr id="27" name="TextBox 26">
            <a:extLst>
              <a:ext uri="{FF2B5EF4-FFF2-40B4-BE49-F238E27FC236}">
                <a16:creationId xmlns:a16="http://schemas.microsoft.com/office/drawing/2014/main" id="{6D7C4F2E-5141-7A45-B726-DB18A7270BD6}"/>
              </a:ext>
            </a:extLst>
          </p:cNvPr>
          <p:cNvSpPr txBox="1"/>
          <p:nvPr/>
        </p:nvSpPr>
        <p:spPr>
          <a:xfrm>
            <a:off x="5888271" y="2460421"/>
            <a:ext cx="962123" cy="200055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Charcoal-Stripped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CE4F8306-FB1A-834E-AF7C-16A9E7E3F0D2}"/>
              </a:ext>
            </a:extLst>
          </p:cNvPr>
          <p:cNvSpPr txBox="1"/>
          <p:nvPr/>
        </p:nvSpPr>
        <p:spPr>
          <a:xfrm>
            <a:off x="5724282" y="4230205"/>
            <a:ext cx="54854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E8183C77-7077-AD47-A40B-658EE2D45B44}"/>
              </a:ext>
            </a:extLst>
          </p:cNvPr>
          <p:cNvSpPr txBox="1"/>
          <p:nvPr/>
        </p:nvSpPr>
        <p:spPr>
          <a:xfrm>
            <a:off x="6128652" y="4333503"/>
            <a:ext cx="56457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15 days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15E06C12-62A3-D546-8E96-B3ADD34746F1}"/>
              </a:ext>
            </a:extLst>
          </p:cNvPr>
          <p:cNvSpPr txBox="1"/>
          <p:nvPr/>
        </p:nvSpPr>
        <p:spPr>
          <a:xfrm>
            <a:off x="6381096" y="4523341"/>
            <a:ext cx="97494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4 days hormone</a:t>
            </a:r>
          </a:p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re-addition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50B6D0B1-732A-AD48-9353-BAD032CAD742}"/>
              </a:ext>
            </a:extLst>
          </p:cNvPr>
          <p:cNvSpPr txBox="1"/>
          <p:nvPr/>
        </p:nvSpPr>
        <p:spPr>
          <a:xfrm>
            <a:off x="6219221" y="2696450"/>
            <a:ext cx="3834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****</a:t>
            </a:r>
          </a:p>
        </p:txBody>
      </p:sp>
    </p:spTree>
    <p:extLst>
      <p:ext uri="{BB962C8B-B14F-4D97-AF65-F5344CB8AC3E}">
        <p14:creationId xmlns:p14="http://schemas.microsoft.com/office/powerpoint/2010/main" val="12220648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0054</TotalTime>
  <Words>127</Words>
  <Application>Microsoft Macintosh PowerPoint</Application>
  <PresentationFormat>On-screen Show (16:10)</PresentationFormat>
  <Paragraphs>25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essandro Fatatis</dc:creator>
  <cp:lastModifiedBy>Alessandro Fatatis</cp:lastModifiedBy>
  <cp:revision>255</cp:revision>
  <dcterms:created xsi:type="dcterms:W3CDTF">2021-08-27T21:58:33Z</dcterms:created>
  <dcterms:modified xsi:type="dcterms:W3CDTF">2022-11-02T10:41:54Z</dcterms:modified>
</cp:coreProperties>
</file>